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6" r:id="rId5"/>
  </p:sldIdLst>
  <p:sldSz cx="6119813" cy="2268538"/>
  <p:notesSz cx="6805613" cy="9939338"/>
  <p:defaultTextStyle>
    <a:defPPr>
      <a:defRPr lang="ja-JP"/>
    </a:defPPr>
    <a:lvl1pPr marL="0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1pPr>
    <a:lvl2pPr marL="490203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2pPr>
    <a:lvl3pPr marL="980402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3pPr>
    <a:lvl4pPr marL="1470606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4pPr>
    <a:lvl5pPr marL="1960807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5pPr>
    <a:lvl6pPr marL="2451008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6pPr>
    <a:lvl7pPr marL="2941209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7pPr>
    <a:lvl8pPr marL="3431412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8pPr>
    <a:lvl9pPr marL="3921613" algn="l" defTabSz="980402" rtl="0" eaLnBrk="1" latinLnBrk="0" hangingPunct="1">
      <a:defRPr kumimoji="1" sz="18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6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178" autoAdjust="0"/>
  </p:normalViewPr>
  <p:slideViewPr>
    <p:cSldViewPr>
      <p:cViewPr>
        <p:scale>
          <a:sx n="150" d="100"/>
          <a:sy n="150" d="100"/>
        </p:scale>
        <p:origin x="186" y="1494"/>
      </p:cViewPr>
      <p:guideLst>
        <p:guide orient="horz" pos="686"/>
        <p:guide pos="1928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檜垣 栄治" userId="f48e0a9b-39a3-4418-9ad4-a8f2cc746e57" providerId="ADAL" clId="{3440C24F-CEBB-4335-B86D-6C6F3FFC7055}"/>
    <pc:docChg chg="undo custSel modSld">
      <pc:chgData name="檜垣 栄治" userId="f48e0a9b-39a3-4418-9ad4-a8f2cc746e57" providerId="ADAL" clId="{3440C24F-CEBB-4335-B86D-6C6F3FFC7055}" dt="2020-05-01T04:54:48.457" v="191" actId="1037"/>
      <pc:docMkLst>
        <pc:docMk/>
      </pc:docMkLst>
      <pc:sldChg chg="addSp delSp modSp mod">
        <pc:chgData name="檜垣 栄治" userId="f48e0a9b-39a3-4418-9ad4-a8f2cc746e57" providerId="ADAL" clId="{3440C24F-CEBB-4335-B86D-6C6F3FFC7055}" dt="2020-05-01T04:54:48.457" v="191" actId="1037"/>
        <pc:sldMkLst>
          <pc:docMk/>
          <pc:sldMk cId="2976527926" sldId="256"/>
        </pc:sldMkLst>
        <pc:spChg chg="add mod">
          <ac:chgData name="檜垣 栄治" userId="f48e0a9b-39a3-4418-9ad4-a8f2cc746e57" providerId="ADAL" clId="{3440C24F-CEBB-4335-B86D-6C6F3FFC7055}" dt="2020-05-01T04:48:47.851" v="103" actId="1076"/>
          <ac:spMkLst>
            <pc:docMk/>
            <pc:sldMk cId="2976527926" sldId="256"/>
            <ac:spMk id="18" creationId="{5A4365C9-037B-4DD9-91B7-89FE222FF232}"/>
          </ac:spMkLst>
        </pc:spChg>
        <pc:spChg chg="add del mod">
          <ac:chgData name="檜垣 栄治" userId="f48e0a9b-39a3-4418-9ad4-a8f2cc746e57" providerId="ADAL" clId="{3440C24F-CEBB-4335-B86D-6C6F3FFC7055}" dt="2020-05-01T04:44:13.988" v="81" actId="478"/>
          <ac:spMkLst>
            <pc:docMk/>
            <pc:sldMk cId="2976527926" sldId="256"/>
            <ac:spMk id="24" creationId="{6A546F4F-0C59-4E25-8BBF-4C0B10332732}"/>
          </ac:spMkLst>
        </pc:spChg>
        <pc:spChg chg="add mod">
          <ac:chgData name="檜垣 栄治" userId="f48e0a9b-39a3-4418-9ad4-a8f2cc746e57" providerId="ADAL" clId="{3440C24F-CEBB-4335-B86D-6C6F3FFC7055}" dt="2020-05-01T04:54:48.457" v="191" actId="1037"/>
          <ac:spMkLst>
            <pc:docMk/>
            <pc:sldMk cId="2976527926" sldId="256"/>
            <ac:spMk id="29" creationId="{D89E3F8B-6A76-4F84-AFF0-7D2917A22B24}"/>
          </ac:spMkLst>
        </pc:spChg>
        <pc:spChg chg="del">
          <ac:chgData name="檜垣 栄治" userId="f48e0a9b-39a3-4418-9ad4-a8f2cc746e57" providerId="ADAL" clId="{3440C24F-CEBB-4335-B86D-6C6F3FFC7055}" dt="2020-04-21T04:38:06.082" v="32" actId="478"/>
          <ac:spMkLst>
            <pc:docMk/>
            <pc:sldMk cId="2976527926" sldId="256"/>
            <ac:spMk id="123" creationId="{BDF82F46-94FD-4A0A-BCB4-5FBDE2A0E07C}"/>
          </ac:spMkLst>
        </pc:spChg>
        <pc:spChg chg="mod">
          <ac:chgData name="檜垣 栄治" userId="f48e0a9b-39a3-4418-9ad4-a8f2cc746e57" providerId="ADAL" clId="{3440C24F-CEBB-4335-B86D-6C6F3FFC7055}" dt="2020-04-21T01:16:20.504" v="22" actId="1037"/>
          <ac:spMkLst>
            <pc:docMk/>
            <pc:sldMk cId="2976527926" sldId="256"/>
            <ac:spMk id="124" creationId="{00875BCF-DEE7-4AB6-BF7E-C7AA15899BAB}"/>
          </ac:spMkLst>
        </pc:spChg>
        <pc:spChg chg="mod">
          <ac:chgData name="檜垣 栄治" userId="f48e0a9b-39a3-4418-9ad4-a8f2cc746e57" providerId="ADAL" clId="{3440C24F-CEBB-4335-B86D-6C6F3FFC7055}" dt="2020-05-01T04:52:55.221" v="160" actId="20577"/>
          <ac:spMkLst>
            <pc:docMk/>
            <pc:sldMk cId="2976527926" sldId="256"/>
            <ac:spMk id="125" creationId="{D418B6F8-B7BE-4609-8AED-B23F1B14E696}"/>
          </ac:spMkLst>
        </pc:spChg>
        <pc:grpChg chg="mod">
          <ac:chgData name="檜垣 栄治" userId="f48e0a9b-39a3-4418-9ad4-a8f2cc746e57" providerId="ADAL" clId="{3440C24F-CEBB-4335-B86D-6C6F3FFC7055}" dt="2020-05-01T04:54:24.748" v="167" actId="1076"/>
          <ac:grpSpMkLst>
            <pc:docMk/>
            <pc:sldMk cId="2976527926" sldId="256"/>
            <ac:grpSpMk id="112" creationId="{B27FBD12-407D-466E-84DD-D41F25C4ED48}"/>
          </ac:grpSpMkLst>
        </pc:grpChg>
        <pc:cxnChg chg="add del mod">
          <ac:chgData name="檜垣 栄治" userId="f48e0a9b-39a3-4418-9ad4-a8f2cc746e57" providerId="ADAL" clId="{3440C24F-CEBB-4335-B86D-6C6F3FFC7055}" dt="2020-05-01T04:50:07.017" v="118" actId="478"/>
          <ac:cxnSpMkLst>
            <pc:docMk/>
            <pc:sldMk cId="2976527926" sldId="256"/>
            <ac:cxnSpMk id="19" creationId="{045BAE9E-5138-48D6-8A2B-23720C05E808}"/>
          </ac:cxnSpMkLst>
        </pc:cxnChg>
        <pc:cxnChg chg="add del mod">
          <ac:chgData name="檜垣 栄治" userId="f48e0a9b-39a3-4418-9ad4-a8f2cc746e57" providerId="ADAL" clId="{3440C24F-CEBB-4335-B86D-6C6F3FFC7055}" dt="2020-05-01T04:50:04.436" v="115" actId="478"/>
          <ac:cxnSpMkLst>
            <pc:docMk/>
            <pc:sldMk cId="2976527926" sldId="256"/>
            <ac:cxnSpMk id="20" creationId="{6CD1C906-189D-42D7-A300-D3730CF771F5}"/>
          </ac:cxnSpMkLst>
        </pc:cxnChg>
        <pc:cxnChg chg="add del mod">
          <ac:chgData name="檜垣 栄治" userId="f48e0a9b-39a3-4418-9ad4-a8f2cc746e57" providerId="ADAL" clId="{3440C24F-CEBB-4335-B86D-6C6F3FFC7055}" dt="2020-05-01T04:50:06.445" v="117" actId="478"/>
          <ac:cxnSpMkLst>
            <pc:docMk/>
            <pc:sldMk cId="2976527926" sldId="256"/>
            <ac:cxnSpMk id="21" creationId="{C04E1148-FBF8-4810-B176-4B8BB65AD8C9}"/>
          </ac:cxnSpMkLst>
        </pc:cxnChg>
        <pc:cxnChg chg="add del mod">
          <ac:chgData name="檜垣 栄治" userId="f48e0a9b-39a3-4418-9ad4-a8f2cc746e57" providerId="ADAL" clId="{3440C24F-CEBB-4335-B86D-6C6F3FFC7055}" dt="2020-05-01T04:50:05.436" v="116" actId="478"/>
          <ac:cxnSpMkLst>
            <pc:docMk/>
            <pc:sldMk cId="2976527926" sldId="256"/>
            <ac:cxnSpMk id="22" creationId="{C7B8E82C-8DCD-490D-AE33-41581AD27770}"/>
          </ac:cxnSpMkLst>
        </pc:cxnChg>
        <pc:cxnChg chg="add mod">
          <ac:chgData name="檜垣 栄治" userId="f48e0a9b-39a3-4418-9ad4-a8f2cc746e57" providerId="ADAL" clId="{3440C24F-CEBB-4335-B86D-6C6F3FFC7055}" dt="2020-05-01T04:51:03.641" v="134" actId="1035"/>
          <ac:cxnSpMkLst>
            <pc:docMk/>
            <pc:sldMk cId="2976527926" sldId="256"/>
            <ac:cxnSpMk id="23" creationId="{7047718F-E8D2-4C18-A47B-000F61E6909E}"/>
          </ac:cxnSpMkLst>
        </pc:cxnChg>
        <pc:cxnChg chg="add mod">
          <ac:chgData name="檜垣 栄治" userId="f48e0a9b-39a3-4418-9ad4-a8f2cc746e57" providerId="ADAL" clId="{3440C24F-CEBB-4335-B86D-6C6F3FFC7055}" dt="2020-05-01T04:50:35.936" v="121" actId="208"/>
          <ac:cxnSpMkLst>
            <pc:docMk/>
            <pc:sldMk cId="2976527926" sldId="256"/>
            <ac:cxnSpMk id="25" creationId="{71D38A3C-D163-4EA2-9B94-4A46F1A5F25D}"/>
          </ac:cxnSpMkLst>
        </pc:cxnChg>
        <pc:cxnChg chg="add del mod">
          <ac:chgData name="檜垣 栄治" userId="f48e0a9b-39a3-4418-9ad4-a8f2cc746e57" providerId="ADAL" clId="{3440C24F-CEBB-4335-B86D-6C6F3FFC7055}" dt="2020-05-01T04:49:54.084" v="111" actId="478"/>
          <ac:cxnSpMkLst>
            <pc:docMk/>
            <pc:sldMk cId="2976527926" sldId="256"/>
            <ac:cxnSpMk id="26" creationId="{D8EAE4C4-14C9-48F4-BEB9-C203A00A4C8F}"/>
          </ac:cxnSpMkLst>
        </pc:cxnChg>
        <pc:cxnChg chg="add mod">
          <ac:chgData name="檜垣 栄治" userId="f48e0a9b-39a3-4418-9ad4-a8f2cc746e57" providerId="ADAL" clId="{3440C24F-CEBB-4335-B86D-6C6F3FFC7055}" dt="2020-05-01T04:50:58.569" v="125" actId="1076"/>
          <ac:cxnSpMkLst>
            <pc:docMk/>
            <pc:sldMk cId="2976527926" sldId="256"/>
            <ac:cxnSpMk id="28" creationId="{5FDB0B94-E726-42D2-8DC0-BBFDB5705D6F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70C28A-0091-44CA-B568-EBDBD0E7F637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-1622425" y="746125"/>
            <a:ext cx="10050463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21186"/>
            <a:ext cx="544449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939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FF63A1-9CBB-481C-9FCD-6F1E0D3488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0674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1pPr>
    <a:lvl2pPr marL="490203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2pPr>
    <a:lvl3pPr marL="980402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3pPr>
    <a:lvl4pPr marL="1470606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4pPr>
    <a:lvl5pPr marL="1960807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5pPr>
    <a:lvl6pPr marL="2451008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6pPr>
    <a:lvl7pPr marL="2941209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7pPr>
    <a:lvl8pPr marL="3431412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8pPr>
    <a:lvl9pPr marL="3921613" algn="l" defTabSz="980402" rtl="0" eaLnBrk="1" latinLnBrk="0" hangingPunct="1">
      <a:defRPr kumimoji="1" sz="133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-1622425" y="746125"/>
            <a:ext cx="10050463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CFF63A1-9CBB-481C-9FCD-6F1E0D34887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68802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59002" y="704725"/>
            <a:ext cx="5201840" cy="486264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17991" y="1285515"/>
            <a:ext cx="4283871" cy="5797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93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8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79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7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965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558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151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744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153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870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218484" y="82454"/>
            <a:ext cx="688481" cy="1758116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153019" y="82454"/>
            <a:ext cx="1963441" cy="1758116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2616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4301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3445" y="1457755"/>
            <a:ext cx="5201840" cy="450556"/>
          </a:xfrm>
        </p:spPr>
        <p:txBody>
          <a:bodyPr anchor="t"/>
          <a:lstStyle>
            <a:lvl1pPr algn="l">
              <a:defRPr sz="522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3445" y="961513"/>
            <a:ext cx="5201840" cy="496242"/>
          </a:xfrm>
        </p:spPr>
        <p:txBody>
          <a:bodyPr anchor="b"/>
          <a:lstStyle>
            <a:lvl1pPr marL="0" indent="0">
              <a:buNone/>
              <a:defRPr sz="265">
                <a:solidFill>
                  <a:schemeClr val="tx1">
                    <a:tint val="75000"/>
                  </a:schemeClr>
                </a:solidFill>
              </a:defRPr>
            </a:lvl1pPr>
            <a:lvl2pPr marL="59308" indent="0">
              <a:buNone/>
              <a:defRPr sz="219">
                <a:solidFill>
                  <a:schemeClr val="tx1">
                    <a:tint val="75000"/>
                  </a:schemeClr>
                </a:solidFill>
              </a:defRPr>
            </a:lvl2pPr>
            <a:lvl3pPr marL="118620" indent="0">
              <a:buNone/>
              <a:defRPr sz="206">
                <a:solidFill>
                  <a:schemeClr val="tx1">
                    <a:tint val="75000"/>
                  </a:schemeClr>
                </a:solidFill>
              </a:defRPr>
            </a:lvl3pPr>
            <a:lvl4pPr marL="177929" indent="0">
              <a:buNone/>
              <a:defRPr sz="185">
                <a:solidFill>
                  <a:schemeClr val="tx1">
                    <a:tint val="75000"/>
                  </a:schemeClr>
                </a:solidFill>
              </a:defRPr>
            </a:lvl4pPr>
            <a:lvl5pPr marL="237240" indent="0">
              <a:buNone/>
              <a:defRPr sz="185">
                <a:solidFill>
                  <a:schemeClr val="tx1">
                    <a:tint val="75000"/>
                  </a:schemeClr>
                </a:solidFill>
              </a:defRPr>
            </a:lvl5pPr>
            <a:lvl6pPr marL="296547" indent="0">
              <a:buNone/>
              <a:defRPr sz="185">
                <a:solidFill>
                  <a:schemeClr val="tx1">
                    <a:tint val="75000"/>
                  </a:schemeClr>
                </a:solidFill>
              </a:defRPr>
            </a:lvl6pPr>
            <a:lvl7pPr marL="355857" indent="0">
              <a:buNone/>
              <a:defRPr sz="185">
                <a:solidFill>
                  <a:schemeClr val="tx1">
                    <a:tint val="75000"/>
                  </a:schemeClr>
                </a:solidFill>
              </a:defRPr>
            </a:lvl7pPr>
            <a:lvl8pPr marL="415168" indent="0">
              <a:buNone/>
              <a:defRPr sz="185">
                <a:solidFill>
                  <a:schemeClr val="tx1">
                    <a:tint val="75000"/>
                  </a:schemeClr>
                </a:solidFill>
              </a:defRPr>
            </a:lvl8pPr>
            <a:lvl9pPr marL="474477" indent="0">
              <a:buNone/>
              <a:defRPr sz="18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5909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153045" y="481022"/>
            <a:ext cx="1325959" cy="1359547"/>
          </a:xfrm>
        </p:spPr>
        <p:txBody>
          <a:bodyPr/>
          <a:lstStyle>
            <a:lvl1pPr>
              <a:defRPr sz="371"/>
            </a:lvl1pPr>
            <a:lvl2pPr>
              <a:defRPr sz="314"/>
            </a:lvl2pPr>
            <a:lvl3pPr>
              <a:defRPr sz="265"/>
            </a:lvl3pPr>
            <a:lvl4pPr>
              <a:defRPr sz="219"/>
            </a:lvl4pPr>
            <a:lvl5pPr>
              <a:defRPr sz="219"/>
            </a:lvl5pPr>
            <a:lvl6pPr>
              <a:defRPr sz="219"/>
            </a:lvl6pPr>
            <a:lvl7pPr>
              <a:defRPr sz="219"/>
            </a:lvl7pPr>
            <a:lvl8pPr>
              <a:defRPr sz="219"/>
            </a:lvl8pPr>
            <a:lvl9pPr>
              <a:defRPr sz="21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1580974" y="481022"/>
            <a:ext cx="1325959" cy="1359547"/>
          </a:xfrm>
        </p:spPr>
        <p:txBody>
          <a:bodyPr/>
          <a:lstStyle>
            <a:lvl1pPr>
              <a:defRPr sz="371"/>
            </a:lvl1pPr>
            <a:lvl2pPr>
              <a:defRPr sz="314"/>
            </a:lvl2pPr>
            <a:lvl3pPr>
              <a:defRPr sz="265"/>
            </a:lvl3pPr>
            <a:lvl4pPr>
              <a:defRPr sz="219"/>
            </a:lvl4pPr>
            <a:lvl5pPr>
              <a:defRPr sz="219"/>
            </a:lvl5pPr>
            <a:lvl6pPr>
              <a:defRPr sz="219"/>
            </a:lvl6pPr>
            <a:lvl7pPr>
              <a:defRPr sz="219"/>
            </a:lvl7pPr>
            <a:lvl8pPr>
              <a:defRPr sz="219"/>
            </a:lvl8pPr>
            <a:lvl9pPr>
              <a:defRPr sz="21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137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5996" y="90856"/>
            <a:ext cx="5507833" cy="37808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6013" y="507805"/>
            <a:ext cx="2703981" cy="211625"/>
          </a:xfrm>
        </p:spPr>
        <p:txBody>
          <a:bodyPr anchor="b"/>
          <a:lstStyle>
            <a:lvl1pPr marL="0" indent="0">
              <a:buNone/>
              <a:defRPr sz="314" b="1"/>
            </a:lvl1pPr>
            <a:lvl2pPr marL="59308" indent="0">
              <a:buNone/>
              <a:defRPr sz="265" b="1"/>
            </a:lvl2pPr>
            <a:lvl3pPr marL="118620" indent="0">
              <a:buNone/>
              <a:defRPr sz="219" b="1"/>
            </a:lvl3pPr>
            <a:lvl4pPr marL="177929" indent="0">
              <a:buNone/>
              <a:defRPr sz="206" b="1"/>
            </a:lvl4pPr>
            <a:lvl5pPr marL="237240" indent="0">
              <a:buNone/>
              <a:defRPr sz="206" b="1"/>
            </a:lvl5pPr>
            <a:lvl6pPr marL="296547" indent="0">
              <a:buNone/>
              <a:defRPr sz="206" b="1"/>
            </a:lvl6pPr>
            <a:lvl7pPr marL="355857" indent="0">
              <a:buNone/>
              <a:defRPr sz="206" b="1"/>
            </a:lvl7pPr>
            <a:lvl8pPr marL="415168" indent="0">
              <a:buNone/>
              <a:defRPr sz="206" b="1"/>
            </a:lvl8pPr>
            <a:lvl9pPr marL="474477" indent="0">
              <a:buNone/>
              <a:defRPr sz="206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06013" y="719431"/>
            <a:ext cx="2703981" cy="1307033"/>
          </a:xfrm>
        </p:spPr>
        <p:txBody>
          <a:bodyPr/>
          <a:lstStyle>
            <a:lvl1pPr>
              <a:defRPr sz="314"/>
            </a:lvl1pPr>
            <a:lvl2pPr>
              <a:defRPr sz="265"/>
            </a:lvl2pPr>
            <a:lvl3pPr>
              <a:defRPr sz="219"/>
            </a:lvl3pPr>
            <a:lvl4pPr>
              <a:defRPr sz="206"/>
            </a:lvl4pPr>
            <a:lvl5pPr>
              <a:defRPr sz="206"/>
            </a:lvl5pPr>
            <a:lvl6pPr>
              <a:defRPr sz="206"/>
            </a:lvl6pPr>
            <a:lvl7pPr>
              <a:defRPr sz="206"/>
            </a:lvl7pPr>
            <a:lvl8pPr>
              <a:defRPr sz="206"/>
            </a:lvl8pPr>
            <a:lvl9pPr>
              <a:defRPr sz="206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108804" y="507805"/>
            <a:ext cx="2705043" cy="211625"/>
          </a:xfrm>
        </p:spPr>
        <p:txBody>
          <a:bodyPr anchor="b"/>
          <a:lstStyle>
            <a:lvl1pPr marL="0" indent="0">
              <a:buNone/>
              <a:defRPr sz="314" b="1"/>
            </a:lvl1pPr>
            <a:lvl2pPr marL="59308" indent="0">
              <a:buNone/>
              <a:defRPr sz="265" b="1"/>
            </a:lvl2pPr>
            <a:lvl3pPr marL="118620" indent="0">
              <a:buNone/>
              <a:defRPr sz="219" b="1"/>
            </a:lvl3pPr>
            <a:lvl4pPr marL="177929" indent="0">
              <a:buNone/>
              <a:defRPr sz="206" b="1"/>
            </a:lvl4pPr>
            <a:lvl5pPr marL="237240" indent="0">
              <a:buNone/>
              <a:defRPr sz="206" b="1"/>
            </a:lvl5pPr>
            <a:lvl6pPr marL="296547" indent="0">
              <a:buNone/>
              <a:defRPr sz="206" b="1"/>
            </a:lvl6pPr>
            <a:lvl7pPr marL="355857" indent="0">
              <a:buNone/>
              <a:defRPr sz="206" b="1"/>
            </a:lvl7pPr>
            <a:lvl8pPr marL="415168" indent="0">
              <a:buNone/>
              <a:defRPr sz="206" b="1"/>
            </a:lvl8pPr>
            <a:lvl9pPr marL="474477" indent="0">
              <a:buNone/>
              <a:defRPr sz="206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108804" y="719431"/>
            <a:ext cx="2705043" cy="1307033"/>
          </a:xfrm>
        </p:spPr>
        <p:txBody>
          <a:bodyPr/>
          <a:lstStyle>
            <a:lvl1pPr>
              <a:defRPr sz="314"/>
            </a:lvl1pPr>
            <a:lvl2pPr>
              <a:defRPr sz="265"/>
            </a:lvl2pPr>
            <a:lvl3pPr>
              <a:defRPr sz="219"/>
            </a:lvl3pPr>
            <a:lvl4pPr>
              <a:defRPr sz="206"/>
            </a:lvl4pPr>
            <a:lvl5pPr>
              <a:defRPr sz="206"/>
            </a:lvl5pPr>
            <a:lvl6pPr>
              <a:defRPr sz="206"/>
            </a:lvl6pPr>
            <a:lvl7pPr>
              <a:defRPr sz="206"/>
            </a:lvl7pPr>
            <a:lvl8pPr>
              <a:defRPr sz="206"/>
            </a:lvl8pPr>
            <a:lvl9pPr>
              <a:defRPr sz="206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044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812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046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6014" y="90332"/>
            <a:ext cx="2013377" cy="384392"/>
          </a:xfrm>
        </p:spPr>
        <p:txBody>
          <a:bodyPr anchor="b"/>
          <a:lstStyle>
            <a:lvl1pPr algn="l">
              <a:defRPr sz="26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392716" y="90330"/>
            <a:ext cx="3421146" cy="1936135"/>
          </a:xfrm>
        </p:spPr>
        <p:txBody>
          <a:bodyPr/>
          <a:lstStyle>
            <a:lvl1pPr>
              <a:defRPr sz="429"/>
            </a:lvl1pPr>
            <a:lvl2pPr>
              <a:defRPr sz="371"/>
            </a:lvl2pPr>
            <a:lvl3pPr>
              <a:defRPr sz="314"/>
            </a:lvl3pPr>
            <a:lvl4pPr>
              <a:defRPr sz="265"/>
            </a:lvl4pPr>
            <a:lvl5pPr>
              <a:defRPr sz="265"/>
            </a:lvl5pPr>
            <a:lvl6pPr>
              <a:defRPr sz="265"/>
            </a:lvl6pPr>
            <a:lvl7pPr>
              <a:defRPr sz="265"/>
            </a:lvl7pPr>
            <a:lvl8pPr>
              <a:defRPr sz="265"/>
            </a:lvl8pPr>
            <a:lvl9pPr>
              <a:defRPr sz="26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06014" y="474724"/>
            <a:ext cx="2013377" cy="1551742"/>
          </a:xfrm>
        </p:spPr>
        <p:txBody>
          <a:bodyPr/>
          <a:lstStyle>
            <a:lvl1pPr marL="0" indent="0">
              <a:buNone/>
              <a:defRPr sz="185"/>
            </a:lvl1pPr>
            <a:lvl2pPr marL="59308" indent="0">
              <a:buNone/>
              <a:defRPr sz="181"/>
            </a:lvl2pPr>
            <a:lvl3pPr marL="118620" indent="0">
              <a:buNone/>
              <a:defRPr sz="181"/>
            </a:lvl3pPr>
            <a:lvl4pPr marL="177929" indent="0">
              <a:buNone/>
              <a:defRPr sz="181"/>
            </a:lvl4pPr>
            <a:lvl5pPr marL="237240" indent="0">
              <a:buNone/>
              <a:defRPr sz="181"/>
            </a:lvl5pPr>
            <a:lvl6pPr marL="296547" indent="0">
              <a:buNone/>
              <a:defRPr sz="181"/>
            </a:lvl6pPr>
            <a:lvl7pPr marL="355857" indent="0">
              <a:buNone/>
              <a:defRPr sz="181"/>
            </a:lvl7pPr>
            <a:lvl8pPr marL="415168" indent="0">
              <a:buNone/>
              <a:defRPr sz="181"/>
            </a:lvl8pPr>
            <a:lvl9pPr marL="474477" indent="0">
              <a:buNone/>
              <a:defRPr sz="18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1540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199549" y="1587989"/>
            <a:ext cx="3671888" cy="187468"/>
          </a:xfrm>
        </p:spPr>
        <p:txBody>
          <a:bodyPr anchor="b"/>
          <a:lstStyle>
            <a:lvl1pPr algn="l">
              <a:defRPr sz="26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199549" y="202710"/>
            <a:ext cx="3671888" cy="1361123"/>
          </a:xfrm>
        </p:spPr>
        <p:txBody>
          <a:bodyPr/>
          <a:lstStyle>
            <a:lvl1pPr marL="0" indent="0">
              <a:buNone/>
              <a:defRPr sz="429"/>
            </a:lvl1pPr>
            <a:lvl2pPr marL="59308" indent="0">
              <a:buNone/>
              <a:defRPr sz="371"/>
            </a:lvl2pPr>
            <a:lvl3pPr marL="118620" indent="0">
              <a:buNone/>
              <a:defRPr sz="314"/>
            </a:lvl3pPr>
            <a:lvl4pPr marL="177929" indent="0">
              <a:buNone/>
              <a:defRPr sz="265"/>
            </a:lvl4pPr>
            <a:lvl5pPr marL="237240" indent="0">
              <a:buNone/>
              <a:defRPr sz="265"/>
            </a:lvl5pPr>
            <a:lvl6pPr marL="296547" indent="0">
              <a:buNone/>
              <a:defRPr sz="265"/>
            </a:lvl6pPr>
            <a:lvl7pPr marL="355857" indent="0">
              <a:buNone/>
              <a:defRPr sz="265"/>
            </a:lvl7pPr>
            <a:lvl8pPr marL="415168" indent="0">
              <a:buNone/>
              <a:defRPr sz="265"/>
            </a:lvl8pPr>
            <a:lvl9pPr marL="474477" indent="0">
              <a:buNone/>
              <a:defRPr sz="26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199549" y="1775457"/>
            <a:ext cx="3671888" cy="266238"/>
          </a:xfrm>
        </p:spPr>
        <p:txBody>
          <a:bodyPr/>
          <a:lstStyle>
            <a:lvl1pPr marL="0" indent="0">
              <a:buNone/>
              <a:defRPr sz="185"/>
            </a:lvl1pPr>
            <a:lvl2pPr marL="59308" indent="0">
              <a:buNone/>
              <a:defRPr sz="181"/>
            </a:lvl2pPr>
            <a:lvl3pPr marL="118620" indent="0">
              <a:buNone/>
              <a:defRPr sz="181"/>
            </a:lvl3pPr>
            <a:lvl4pPr marL="177929" indent="0">
              <a:buNone/>
              <a:defRPr sz="181"/>
            </a:lvl4pPr>
            <a:lvl5pPr marL="237240" indent="0">
              <a:buNone/>
              <a:defRPr sz="181"/>
            </a:lvl5pPr>
            <a:lvl6pPr marL="296547" indent="0">
              <a:buNone/>
              <a:defRPr sz="181"/>
            </a:lvl6pPr>
            <a:lvl7pPr marL="355857" indent="0">
              <a:buNone/>
              <a:defRPr sz="181"/>
            </a:lvl7pPr>
            <a:lvl8pPr marL="415168" indent="0">
              <a:buNone/>
              <a:defRPr sz="181"/>
            </a:lvl8pPr>
            <a:lvl9pPr marL="474477" indent="0">
              <a:buNone/>
              <a:defRPr sz="18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513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05996" y="90856"/>
            <a:ext cx="5507833" cy="378089"/>
          </a:xfrm>
          <a:prstGeom prst="rect">
            <a:avLst/>
          </a:prstGeom>
        </p:spPr>
        <p:txBody>
          <a:bodyPr vert="horz" lIns="102531" tIns="51265" rIns="102531" bIns="51265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5996" y="529331"/>
            <a:ext cx="5507833" cy="1497131"/>
          </a:xfrm>
          <a:prstGeom prst="rect">
            <a:avLst/>
          </a:prstGeom>
        </p:spPr>
        <p:txBody>
          <a:bodyPr vert="horz" lIns="102531" tIns="51265" rIns="102531" bIns="51265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05994" y="2102607"/>
            <a:ext cx="1427959" cy="120779"/>
          </a:xfrm>
          <a:prstGeom prst="rect">
            <a:avLst/>
          </a:prstGeom>
        </p:spPr>
        <p:txBody>
          <a:bodyPr vert="horz" lIns="102531" tIns="51265" rIns="102531" bIns="51265" rtlCol="0" anchor="ctr"/>
          <a:lstStyle>
            <a:lvl1pPr algn="l">
              <a:defRPr sz="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70E566-C781-460C-BC0D-E8040D834BDA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090947" y="2102607"/>
            <a:ext cx="1937942" cy="120779"/>
          </a:xfrm>
          <a:prstGeom prst="rect">
            <a:avLst/>
          </a:prstGeom>
        </p:spPr>
        <p:txBody>
          <a:bodyPr vert="horz" lIns="102531" tIns="51265" rIns="102531" bIns="51265" rtlCol="0" anchor="ctr"/>
          <a:lstStyle>
            <a:lvl1pPr algn="ctr">
              <a:defRPr sz="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385875" y="2102607"/>
            <a:ext cx="1427959" cy="120779"/>
          </a:xfrm>
          <a:prstGeom prst="rect">
            <a:avLst/>
          </a:prstGeom>
        </p:spPr>
        <p:txBody>
          <a:bodyPr vert="horz" lIns="102531" tIns="51265" rIns="102531" bIns="51265" rtlCol="0" anchor="ctr"/>
          <a:lstStyle>
            <a:lvl1pPr algn="r">
              <a:defRPr sz="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766D6-6883-4DA3-BBF8-3C34B3136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4443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8620" rtl="0" eaLnBrk="1" latinLnBrk="0" hangingPunct="1">
        <a:spcBef>
          <a:spcPct val="0"/>
        </a:spcBef>
        <a:buNone/>
        <a:defRPr kumimoji="1" sz="57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4482" indent="-44482" algn="l" defTabSz="11862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9" kern="1200">
          <a:solidFill>
            <a:schemeClr val="tx1"/>
          </a:solidFill>
          <a:latin typeface="+mn-lt"/>
          <a:ea typeface="+mn-ea"/>
          <a:cs typeface="+mn-cs"/>
        </a:defRPr>
      </a:lvl1pPr>
      <a:lvl2pPr marL="96380" indent="-37070" algn="l" defTabSz="11862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71" kern="1200">
          <a:solidFill>
            <a:schemeClr val="tx1"/>
          </a:solidFill>
          <a:latin typeface="+mn-lt"/>
          <a:ea typeface="+mn-ea"/>
          <a:cs typeface="+mn-cs"/>
        </a:defRPr>
      </a:lvl2pPr>
      <a:lvl3pPr marL="148274" indent="-29655" algn="l" defTabSz="11862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14" kern="1200">
          <a:solidFill>
            <a:schemeClr val="tx1"/>
          </a:solidFill>
          <a:latin typeface="+mn-lt"/>
          <a:ea typeface="+mn-ea"/>
          <a:cs typeface="+mn-cs"/>
        </a:defRPr>
      </a:lvl3pPr>
      <a:lvl4pPr marL="207585" indent="-29655" algn="l" defTabSz="11862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65" kern="1200">
          <a:solidFill>
            <a:schemeClr val="tx1"/>
          </a:solidFill>
          <a:latin typeface="+mn-lt"/>
          <a:ea typeface="+mn-ea"/>
          <a:cs typeface="+mn-cs"/>
        </a:defRPr>
      </a:lvl4pPr>
      <a:lvl5pPr marL="266891" indent="-29655" algn="l" defTabSz="11862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65" kern="1200">
          <a:solidFill>
            <a:schemeClr val="tx1"/>
          </a:solidFill>
          <a:latin typeface="+mn-lt"/>
          <a:ea typeface="+mn-ea"/>
          <a:cs typeface="+mn-cs"/>
        </a:defRPr>
      </a:lvl5pPr>
      <a:lvl6pPr marL="326202" indent="-29655" algn="l" defTabSz="11862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5" kern="1200">
          <a:solidFill>
            <a:schemeClr val="tx1"/>
          </a:solidFill>
          <a:latin typeface="+mn-lt"/>
          <a:ea typeface="+mn-ea"/>
          <a:cs typeface="+mn-cs"/>
        </a:defRPr>
      </a:lvl6pPr>
      <a:lvl7pPr marL="385512" indent="-29655" algn="l" defTabSz="11862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5" kern="1200">
          <a:solidFill>
            <a:schemeClr val="tx1"/>
          </a:solidFill>
          <a:latin typeface="+mn-lt"/>
          <a:ea typeface="+mn-ea"/>
          <a:cs typeface="+mn-cs"/>
        </a:defRPr>
      </a:lvl7pPr>
      <a:lvl8pPr marL="444820" indent="-29655" algn="l" defTabSz="11862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5" kern="1200">
          <a:solidFill>
            <a:schemeClr val="tx1"/>
          </a:solidFill>
          <a:latin typeface="+mn-lt"/>
          <a:ea typeface="+mn-ea"/>
          <a:cs typeface="+mn-cs"/>
        </a:defRPr>
      </a:lvl8pPr>
      <a:lvl9pPr marL="504131" indent="-29655" algn="l" defTabSz="11862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1pPr>
      <a:lvl2pPr marL="59308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2pPr>
      <a:lvl3pPr marL="118620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3pPr>
      <a:lvl4pPr marL="177929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4pPr>
      <a:lvl5pPr marL="237240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5pPr>
      <a:lvl6pPr marL="296547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6pPr>
      <a:lvl7pPr marL="355857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7pPr>
      <a:lvl8pPr marL="415168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8pPr>
      <a:lvl9pPr marL="474477" algn="l" defTabSz="118620" rtl="0" eaLnBrk="1" latinLnBrk="0" hangingPunct="1">
        <a:defRPr kumimoji="1" sz="21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B27FBD12-407D-466E-84DD-D41F25C4ED48}"/>
              </a:ext>
            </a:extLst>
          </p:cNvPr>
          <p:cNvGrpSpPr/>
          <p:nvPr/>
        </p:nvGrpSpPr>
        <p:grpSpPr>
          <a:xfrm>
            <a:off x="-48417" y="20135"/>
            <a:ext cx="6446661" cy="2246824"/>
            <a:chOff x="-48417" y="20135"/>
            <a:chExt cx="6446661" cy="2246824"/>
          </a:xfrm>
        </p:grpSpPr>
        <p:grpSp>
          <p:nvGrpSpPr>
            <p:cNvPr id="113" name="グループ化 112">
              <a:extLst>
                <a:ext uri="{FF2B5EF4-FFF2-40B4-BE49-F238E27FC236}">
                  <a16:creationId xmlns:a16="http://schemas.microsoft.com/office/drawing/2014/main" id="{96C947CE-EE61-4426-8055-36DF73D1BB99}"/>
                </a:ext>
              </a:extLst>
            </p:cNvPr>
            <p:cNvGrpSpPr/>
            <p:nvPr/>
          </p:nvGrpSpPr>
          <p:grpSpPr>
            <a:xfrm>
              <a:off x="-48417" y="35639"/>
              <a:ext cx="6446661" cy="2231320"/>
              <a:chOff x="-88866" y="-446"/>
              <a:chExt cx="6446661" cy="2231320"/>
            </a:xfrm>
          </p:grpSpPr>
          <p:grpSp>
            <p:nvGrpSpPr>
              <p:cNvPr id="118" name="グループ化 117">
                <a:extLst>
                  <a:ext uri="{FF2B5EF4-FFF2-40B4-BE49-F238E27FC236}">
                    <a16:creationId xmlns:a16="http://schemas.microsoft.com/office/drawing/2014/main" id="{5D976DA6-D02A-4B4B-9C37-BC7B72C9BE9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-149" y="-446"/>
                <a:ext cx="6046658" cy="1612035"/>
                <a:chOff x="0" y="-6368"/>
                <a:chExt cx="5168686" cy="1377968"/>
              </a:xfrm>
            </p:grpSpPr>
            <p:pic>
              <p:nvPicPr>
                <p:cNvPr id="126" name="図 125">
                  <a:extLst>
                    <a:ext uri="{FF2B5EF4-FFF2-40B4-BE49-F238E27FC236}">
                      <a16:creationId xmlns:a16="http://schemas.microsoft.com/office/drawing/2014/main" id="{032EB040-FFC3-4364-8A07-999309FC1F80}"/>
                    </a:ext>
                  </a:extLst>
                </p:cNvPr>
                <p:cNvPicPr/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6350"/>
                <a:stretch/>
              </p:blipFill>
              <p:spPr bwMode="auto">
                <a:xfrm>
                  <a:off x="0" y="0"/>
                  <a:ext cx="1656184" cy="13716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127" name="図 126">
                  <a:extLst>
                    <a:ext uri="{FF2B5EF4-FFF2-40B4-BE49-F238E27FC236}">
                      <a16:creationId xmlns:a16="http://schemas.microsoft.com/office/drawing/2014/main" id="{8CEC0326-A3D6-4A9A-815A-F906B1743795}"/>
                    </a:ext>
                  </a:extLst>
                </p:cNvPr>
                <p:cNvPicPr/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75551" y="-6368"/>
                  <a:ext cx="1736725" cy="137795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128" name="図 127">
                  <a:extLst>
                    <a:ext uri="{FF2B5EF4-FFF2-40B4-BE49-F238E27FC236}">
                      <a16:creationId xmlns:a16="http://schemas.microsoft.com/office/drawing/2014/main" id="{014B468F-7048-427F-8B4B-FDC4B21B5D56}"/>
                    </a:ext>
                  </a:extLst>
                </p:cNvPr>
                <p:cNvPicPr/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81"/>
                <a:stretch/>
              </p:blipFill>
              <p:spPr bwMode="auto">
                <a:xfrm>
                  <a:off x="3431961" y="-2558"/>
                  <a:ext cx="1736725" cy="137414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</p:grp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A7490EF0-D616-44B7-982C-4D8E0E633D47}"/>
                  </a:ext>
                </a:extLst>
              </p:cNvPr>
              <p:cNvSpPr txBox="1"/>
              <p:nvPr/>
            </p:nvSpPr>
            <p:spPr>
              <a:xfrm rot="807258">
                <a:off x="519351" y="1226461"/>
                <a:ext cx="1092417" cy="261610"/>
              </a:xfrm>
              <a:prstGeom prst="rect">
                <a:avLst/>
              </a:prstGeom>
              <a:noFill/>
              <a:effectLst>
                <a:outerShdw blurRad="50800" dist="25400" dir="5400000" algn="ctr" rotWithShape="0">
                  <a:srgbClr val="000000"/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esophagus</a:t>
                </a:r>
                <a:endParaRPr lang="ja-JP" altLang="en-US" sz="1050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テキスト ボックス 119">
                <a:extLst>
                  <a:ext uri="{FF2B5EF4-FFF2-40B4-BE49-F238E27FC236}">
                    <a16:creationId xmlns:a16="http://schemas.microsoft.com/office/drawing/2014/main" id="{C68CC554-0954-426A-B4FE-0BA966F22DF0}"/>
                  </a:ext>
                </a:extLst>
              </p:cNvPr>
              <p:cNvSpPr txBox="1"/>
              <p:nvPr/>
            </p:nvSpPr>
            <p:spPr>
              <a:xfrm rot="807258">
                <a:off x="3129252" y="972159"/>
                <a:ext cx="1092417" cy="261610"/>
              </a:xfrm>
              <a:prstGeom prst="rect">
                <a:avLst/>
              </a:prstGeom>
              <a:noFill/>
              <a:effectLst>
                <a:outerShdw blurRad="50800" dist="25400" dir="5400000" algn="ctr" rotWithShape="0">
                  <a:srgbClr val="000000"/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esophagus</a:t>
                </a:r>
                <a:endParaRPr lang="ja-JP" altLang="en-US" sz="1050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テキスト ボックス 120">
                <a:extLst>
                  <a:ext uri="{FF2B5EF4-FFF2-40B4-BE49-F238E27FC236}">
                    <a16:creationId xmlns:a16="http://schemas.microsoft.com/office/drawing/2014/main" id="{033D146F-2BC4-4B57-89CD-FF0469BCC638}"/>
                  </a:ext>
                </a:extLst>
              </p:cNvPr>
              <p:cNvSpPr txBox="1"/>
              <p:nvPr/>
            </p:nvSpPr>
            <p:spPr>
              <a:xfrm rot="20518897">
                <a:off x="5265378" y="900067"/>
                <a:ext cx="1092417" cy="261610"/>
              </a:xfrm>
              <a:prstGeom prst="rect">
                <a:avLst/>
              </a:prstGeom>
              <a:noFill/>
              <a:effectLst>
                <a:outerShdw blurRad="50800" dist="25400" dir="5400000" algn="ctr" rotWithShape="0">
                  <a:srgbClr val="000000"/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esophagus</a:t>
                </a:r>
                <a:endParaRPr lang="ja-JP" altLang="en-US" sz="1050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EBCC3992-9B62-4072-A03A-4EF54D2E608C}"/>
                  </a:ext>
                </a:extLst>
              </p:cNvPr>
              <p:cNvSpPr txBox="1"/>
              <p:nvPr/>
            </p:nvSpPr>
            <p:spPr>
              <a:xfrm rot="20315529">
                <a:off x="5007167" y="264944"/>
                <a:ext cx="625101" cy="261610"/>
              </a:xfrm>
              <a:prstGeom prst="rect">
                <a:avLst/>
              </a:prstGeom>
              <a:noFill/>
              <a:effectLst>
                <a:outerShdw blurRad="50800" dist="25400" dir="5400000" algn="ctr" rotWithShape="0">
                  <a:srgbClr val="000000"/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aorta</a:t>
                </a:r>
                <a:endParaRPr lang="ja-JP" altLang="en-US" sz="1200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正方形/長方形 123">
                <a:extLst>
                  <a:ext uri="{FF2B5EF4-FFF2-40B4-BE49-F238E27FC236}">
                    <a16:creationId xmlns:a16="http://schemas.microsoft.com/office/drawing/2014/main" id="{00875BCF-DEE7-4AB6-BF7E-C7AA15899BAB}"/>
                  </a:ext>
                </a:extLst>
              </p:cNvPr>
              <p:cNvSpPr/>
              <p:nvPr/>
            </p:nvSpPr>
            <p:spPr>
              <a:xfrm>
                <a:off x="-88866" y="1655738"/>
                <a:ext cx="1519968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050" kern="0" dirty="0">
                    <a:solidFill>
                      <a:srgbClr val="000000"/>
                    </a:solidFill>
                    <a:latin typeface="Arial" panose="020B0604020202020204" pitchFamily="34" charset="0"/>
                    <a:ea typeface="ＭＳ 明朝" panose="02020609040205080304" pitchFamily="17" charset="-128"/>
                    <a:cs typeface="Arial" panose="020B0604020202020204" pitchFamily="34" charset="0"/>
                  </a:rPr>
                  <a:t>Supplementary Fig.S1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D418B6F8-B7BE-4609-8AED-B23F1B14E696}"/>
                  </a:ext>
                </a:extLst>
              </p:cNvPr>
              <p:cNvSpPr/>
              <p:nvPr/>
            </p:nvSpPr>
            <p:spPr>
              <a:xfrm>
                <a:off x="1285319" y="1653793"/>
                <a:ext cx="4753745" cy="57708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Firstly, the operation was started from the normal anatomical region(a) and</a:t>
                </a:r>
                <a:r>
                  <a:rPr lang="ja-JP" alt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hen the dissection line was connected to the fibrotic region(b), confirming the adjacent normal anatomy with magnified view(c).</a:t>
                </a:r>
                <a:endParaRPr lang="ja-JP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4" name="グループ化 113">
              <a:extLst>
                <a:ext uri="{FF2B5EF4-FFF2-40B4-BE49-F238E27FC236}">
                  <a16:creationId xmlns:a16="http://schemas.microsoft.com/office/drawing/2014/main" id="{030B0CEB-D9DC-4F41-9708-31B2CD673FB0}"/>
                </a:ext>
              </a:extLst>
            </p:cNvPr>
            <p:cNvGrpSpPr/>
            <p:nvPr/>
          </p:nvGrpSpPr>
          <p:grpSpPr>
            <a:xfrm>
              <a:off x="4319" y="20135"/>
              <a:ext cx="5995957" cy="329725"/>
              <a:chOff x="4319" y="20135"/>
              <a:chExt cx="5995957" cy="329725"/>
            </a:xfrm>
          </p:grpSpPr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9CB8B70A-AA14-4498-866C-830995411B7F}"/>
                  </a:ext>
                </a:extLst>
              </p:cNvPr>
              <p:cNvSpPr txBox="1"/>
              <p:nvPr/>
            </p:nvSpPr>
            <p:spPr>
              <a:xfrm>
                <a:off x="4319" y="42083"/>
                <a:ext cx="1996506" cy="307777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ja-JP" sz="1400" b="1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lang="ja-JP" altLang="en-US" sz="1400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E9BE4BE6-91AC-47EF-A8D5-C0E58E670CD7}"/>
                  </a:ext>
                </a:extLst>
              </p:cNvPr>
              <p:cNvSpPr txBox="1"/>
              <p:nvPr/>
            </p:nvSpPr>
            <p:spPr>
              <a:xfrm>
                <a:off x="1972629" y="21747"/>
                <a:ext cx="1996506" cy="307777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ja-JP" sz="1400" b="1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lang="ja-JP" altLang="en-US" sz="1400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77B3CFD2-24A8-4353-A3BD-D279B28B8FA6}"/>
                  </a:ext>
                </a:extLst>
              </p:cNvPr>
              <p:cNvSpPr txBox="1"/>
              <p:nvPr/>
            </p:nvSpPr>
            <p:spPr>
              <a:xfrm>
                <a:off x="4003770" y="20135"/>
                <a:ext cx="1996506" cy="307777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ja-JP" sz="1400" b="1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lang="ja-JP" altLang="en-US" sz="1400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A4365C9-037B-4DD9-91B7-89FE222FF232}"/>
              </a:ext>
            </a:extLst>
          </p:cNvPr>
          <p:cNvSpPr txBox="1"/>
          <p:nvPr/>
        </p:nvSpPr>
        <p:spPr>
          <a:xfrm>
            <a:off x="2573827" y="1234328"/>
            <a:ext cx="625374" cy="230832"/>
          </a:xfrm>
          <a:prstGeom prst="rect">
            <a:avLst/>
          </a:prstGeom>
          <a:noFill/>
          <a:effectLst>
            <a:outerShdw blurRad="50800" dist="25400" dir="5400000" algn="ctr" rotWithShape="0">
              <a:srgbClr val="000000"/>
            </a:outerShdw>
          </a:effectLst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  <a:endParaRPr lang="ja-JP" altLang="en-US" sz="900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7047718F-E8D2-4C18-A47B-000F61E6909E}"/>
              </a:ext>
            </a:extLst>
          </p:cNvPr>
          <p:cNvCxnSpPr>
            <a:cxnSpLocks/>
          </p:cNvCxnSpPr>
          <p:nvPr/>
        </p:nvCxnSpPr>
        <p:spPr>
          <a:xfrm>
            <a:off x="2919995" y="533497"/>
            <a:ext cx="28802" cy="11370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71D38A3C-D163-4EA2-9B94-4A46F1A5F25D}"/>
              </a:ext>
            </a:extLst>
          </p:cNvPr>
          <p:cNvCxnSpPr>
            <a:cxnSpLocks/>
          </p:cNvCxnSpPr>
          <p:nvPr/>
        </p:nvCxnSpPr>
        <p:spPr>
          <a:xfrm>
            <a:off x="3031104" y="512350"/>
            <a:ext cx="28802" cy="11370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5FDB0B94-E726-42D2-8DC0-BBFDB5705D6F}"/>
              </a:ext>
            </a:extLst>
          </p:cNvPr>
          <p:cNvCxnSpPr>
            <a:cxnSpLocks/>
          </p:cNvCxnSpPr>
          <p:nvPr/>
        </p:nvCxnSpPr>
        <p:spPr>
          <a:xfrm>
            <a:off x="2775799" y="565404"/>
            <a:ext cx="28802" cy="11370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89E3F8B-6A76-4F84-AFF0-7D2917A22B24}"/>
              </a:ext>
            </a:extLst>
          </p:cNvPr>
          <p:cNvSpPr txBox="1"/>
          <p:nvPr/>
        </p:nvSpPr>
        <p:spPr>
          <a:xfrm>
            <a:off x="4013147" y="1380538"/>
            <a:ext cx="932217" cy="261610"/>
          </a:xfrm>
          <a:prstGeom prst="rect">
            <a:avLst/>
          </a:prstGeom>
          <a:noFill/>
          <a:effectLst>
            <a:outerShdw blurRad="50800" dist="25400" dir="5400000" algn="ctr" rotWithShape="0">
              <a:srgbClr val="000000"/>
            </a:outerShdw>
          </a:effectLst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iaphragm</a:t>
            </a:r>
            <a:endParaRPr lang="ja-JP" altLang="en-US" sz="1200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6527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AAA600AA71713488CBA7600C2911880" ma:contentTypeVersion="13" ma:contentTypeDescription="新しいドキュメントを作成します。" ma:contentTypeScope="" ma:versionID="3f83aaf0245bbecc67344f94d2f1e503">
  <xsd:schema xmlns:xsd="http://www.w3.org/2001/XMLSchema" xmlns:xs="http://www.w3.org/2001/XMLSchema" xmlns:p="http://schemas.microsoft.com/office/2006/metadata/properties" xmlns:ns3="61056c80-8825-454f-ab47-7b35b48d8c9a" xmlns:ns4="1820dda8-d856-4998-9c21-98104c9e5bae" targetNamespace="http://schemas.microsoft.com/office/2006/metadata/properties" ma:root="true" ma:fieldsID="c60ae9822352206c278e0294b8e82199" ns3:_="" ns4:_="">
    <xsd:import namespace="61056c80-8825-454f-ab47-7b35b48d8c9a"/>
    <xsd:import namespace="1820dda8-d856-4998-9c21-98104c9e5ba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1056c80-8825-454f-ab47-7b35b48d8c9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0dda8-d856-4998-9c21-98104c9e5bae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D38941F-97E8-4985-A960-6B6744C8CF7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1056c80-8825-454f-ab47-7b35b48d8c9a"/>
    <ds:schemaRef ds:uri="1820dda8-d856-4998-9c21-98104c9e5ba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8B8B34C-599D-4E96-B818-C17606F05C7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22952EB-289C-4591-8FDE-58C4E1ED36EA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48</TotalTime>
  <Words>59</Words>
  <Application>Microsoft Office PowerPoint</Application>
  <PresentationFormat>ユーザー設定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gaki</dc:creator>
  <cp:lastModifiedBy>ehigaki10@gmail.com</cp:lastModifiedBy>
  <cp:revision>85</cp:revision>
  <cp:lastPrinted>2014-08-05T15:00:01Z</cp:lastPrinted>
  <dcterms:created xsi:type="dcterms:W3CDTF">2014-07-02T17:56:17Z</dcterms:created>
  <dcterms:modified xsi:type="dcterms:W3CDTF">2020-05-01T04:55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AAA600AA71713488CBA7600C2911880</vt:lpwstr>
  </property>
</Properties>
</file>